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1002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28" y="908720"/>
            <a:ext cx="8191446" cy="331236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9512" y="4653136"/>
            <a:ext cx="8784976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1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ially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xpressed genes in three comparison groups with 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-interaction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t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pollen sterility loci (i.e. have neutral genes at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loci)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Number of differentially expressed genes in three groups. Genes were designated as up- or down-regulated if their expression levels increased or decreased at least two-fold (P&lt;0.05), respectively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Venn diagram of gene expression overlaps in three groups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211490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4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7</cp:revision>
  <dcterms:modified xsi:type="dcterms:W3CDTF">2017-10-19T08:23:26Z</dcterms:modified>
</cp:coreProperties>
</file>